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9342778-28B4-46E8-B57B-AB6F2A718F41}" v="2" dt="2025-06-09T09:18:40.0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0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ya Engler" userId="1252e1b0b8bb23a8" providerId="LiveId" clId="{29342778-28B4-46E8-B57B-AB6F2A718F41}"/>
    <pc:docChg chg="undo custSel modSld">
      <pc:chgData name="Maya Engler" userId="1252e1b0b8bb23a8" providerId="LiveId" clId="{29342778-28B4-46E8-B57B-AB6F2A718F41}" dt="2025-06-17T07:30:27.156" v="217" actId="20577"/>
      <pc:docMkLst>
        <pc:docMk/>
      </pc:docMkLst>
      <pc:sldChg chg="addSp modSp mod">
        <pc:chgData name="Maya Engler" userId="1252e1b0b8bb23a8" providerId="LiveId" clId="{29342778-28B4-46E8-B57B-AB6F2A718F41}" dt="2025-06-17T07:30:27.156" v="217" actId="20577"/>
        <pc:sldMkLst>
          <pc:docMk/>
          <pc:sldMk cId="3253982571" sldId="256"/>
        </pc:sldMkLst>
        <pc:graphicFrameChg chg="mod modGraphic">
          <ac:chgData name="Maya Engler" userId="1252e1b0b8bb23a8" providerId="LiveId" clId="{29342778-28B4-46E8-B57B-AB6F2A718F41}" dt="2025-06-17T07:30:27.156" v="217" actId="20577"/>
          <ac:graphicFrameMkLst>
            <pc:docMk/>
            <pc:sldMk cId="3253982571" sldId="256"/>
            <ac:graphicFrameMk id="4" creationId="{C5BBC1E3-90D1-CABE-AE91-33C4420C25A4}"/>
          </ac:graphicFrameMkLst>
        </pc:graphicFrameChg>
        <pc:graphicFrameChg chg="add mod modGraphic">
          <ac:chgData name="Maya Engler" userId="1252e1b0b8bb23a8" providerId="LiveId" clId="{29342778-28B4-46E8-B57B-AB6F2A718F41}" dt="2025-06-09T09:18:52.887" v="7" actId="1076"/>
          <ac:graphicFrameMkLst>
            <pc:docMk/>
            <pc:sldMk cId="3253982571" sldId="256"/>
            <ac:graphicFrameMk id="6" creationId="{E6497E06-0269-AE00-E854-1223DE729EF4}"/>
          </ac:graphicFrameMkLst>
        </pc:graphicFrameChg>
        <pc:graphicFrameChg chg="add mod modGraphic">
          <ac:chgData name="Maya Engler" userId="1252e1b0b8bb23a8" providerId="LiveId" clId="{29342778-28B4-46E8-B57B-AB6F2A718F41}" dt="2025-06-17T07:29:28.310" v="207" actId="1076"/>
          <ac:graphicFrameMkLst>
            <pc:docMk/>
            <pc:sldMk cId="3253982571" sldId="256"/>
            <ac:graphicFrameMk id="7" creationId="{FBCBF87F-06BC-401F-8295-18C903C33DFC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B9CF961-87B0-66D1-8D1F-A62554793B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56FA6EB0-9A69-047E-3ED9-42C1E85778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28E552AC-E4A4-2CCE-A9AB-E76AD8B56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8D2AE5A5-ECB8-1A15-89A8-EC20EC720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E6F29ACE-284D-DF56-113A-6432D0E3D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34163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DA8AD3FD-E4F6-6654-3F7A-281160027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1C2C422E-3D61-0C04-A6F5-36EF0D632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37F6203-64C5-3D82-6E6A-55CFEFED1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32897FBC-DBDD-2504-F99C-CAB6B317E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FD2D4B90-2F16-437B-73C8-A1DA28D99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5744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38BB5F3D-E699-FD8A-3E12-78B1C70FEA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643A2E3B-C532-88D1-331C-E8BEBB3A08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78840CF-1369-6CCD-F3A1-01B767206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C92E7510-754B-C0C7-3DCC-A7CD56D4D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A184E516-FE43-997C-3492-76C06A5E5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97889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CC48788-FF1F-A0F8-9F4D-5D30741A0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6E9FA6E7-EB0B-28F0-05B6-FAB694EA85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01902EC-A83C-CFA2-1130-D0A2420B1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44E8793A-AD01-1F51-148F-041D346EC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E653B02E-4091-A321-1D3C-C76D31670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59632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B5E6E5DF-DAEF-E4C6-A25C-8333BA447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1F97E634-5E2E-9BB2-EB72-E812641D73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E26113FC-F423-28B1-3EBD-7629F8635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BFF8BBD7-714D-D599-4C23-7873956A0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4404AC5A-C3DD-29B5-5D1D-34C856772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48645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A0C6C1C-11A0-BB32-1508-EFFC9C4D57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4808BF16-DADE-187A-2445-5B9D44BDD7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F2767926-151D-BF43-D187-DA943C86D8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EBE238CB-4019-EB8F-3123-4C9831FEB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CB58E6DE-99C6-6E68-16F3-31077566C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3E9EB55F-E052-77AE-67F8-A8AF5ECF7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21419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3F64915D-447A-54FA-DDA4-03AD65191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2EF32C56-6B02-CFA5-EC00-4AC11F8C5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6B9C670A-6AA0-6B21-2F08-E812CF38D3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963820A9-504C-765B-1443-CF2C32EB93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C704A3AD-BE73-5A63-E7E8-5F9CB09407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9A843C8C-4750-9C15-B7D0-01A90AF6E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6643C10C-9270-6B35-1CA3-9FFBD01A1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F45EE973-3521-0B23-D3B7-74BD09A0F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60889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013F28D-5A80-AD6C-7F94-CAFDC6BDA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E1B77E4E-9750-2AE0-1432-F495AC3C7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C5F33698-A484-378D-0134-CC95B733A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920B0A54-0828-49AA-CB3B-6A56C2EE1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42668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848C1B17-9804-CD34-531C-25BE69A94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45546A9A-AF95-E6B5-F068-6CFD058BC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F602B03D-6E50-1A67-9919-DD8251E7A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70974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A9018E0A-CF03-6B29-BCB2-07FDAD955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4F2D6E15-C8E7-EAE7-4BB4-492F1054A3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3DDDB923-130F-2B68-0348-3D433629BD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9679A461-99ED-94B7-AFA9-75D67CDBD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714C80BB-AE95-6443-5A66-EA48D7683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1813FBC0-F0CC-F76C-0010-1FD5CFF80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11686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7C7E777E-2A1A-7AB2-F389-684DD9C3F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FA561F14-78B5-49B4-6BCC-B4BF9C5C4F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CE3C5F45-7265-FC39-FE51-9EA8B28265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75137FBF-BBEC-7AC4-21E8-2D67A5AE4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4998C3CD-9221-C1AA-7E98-8C02C0BF5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925FF58D-6B4A-1372-7EBC-6EE2ACA68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81245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F60D2B02-6EED-9A09-985D-F5750DBED0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E97C7976-C1D4-2732-D346-69FD83D5AF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B43AEE0-3177-00E5-EE42-CDF721D0C0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635F55-08F0-43C9-85AD-F9519E9E45E5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DC191B21-3D3C-2F29-E6E2-4B35B3AA78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388A535A-A044-0F74-61BC-15BAADF1BA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10C6A0-38D3-45E3-86EC-016F0D55465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6097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C5BBC1E3-90D1-CABE-AE91-33C4420C25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8210908"/>
              </p:ext>
            </p:extLst>
          </p:nvPr>
        </p:nvGraphicFramePr>
        <p:xfrm>
          <a:off x="274320" y="59548"/>
          <a:ext cx="5121402" cy="44878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35522">
                  <a:extLst>
                    <a:ext uri="{9D8B030D-6E8A-4147-A177-3AD203B41FA5}">
                      <a16:colId xmlns:a16="http://schemas.microsoft.com/office/drawing/2014/main" val="3832596945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1694240550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3811907978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3417042052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3510514394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2591322475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4235742552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2059069958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3386508372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1025642838"/>
                    </a:ext>
                  </a:extLst>
                </a:gridCol>
                <a:gridCol w="348588">
                  <a:extLst>
                    <a:ext uri="{9D8B030D-6E8A-4147-A177-3AD203B41FA5}">
                      <a16:colId xmlns:a16="http://schemas.microsoft.com/office/drawing/2014/main" val="737626515"/>
                    </a:ext>
                  </a:extLst>
                </a:gridCol>
              </a:tblGrid>
              <a:tr h="168284">
                <a:tc>
                  <a:txBody>
                    <a:bodyPr/>
                    <a:lstStyle/>
                    <a:p>
                      <a:pPr algn="l" rtl="0" fontAlgn="b"/>
                      <a:r>
                        <a:rPr lang="he-IL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>
                          <a:effectLst/>
                        </a:rPr>
                        <a:t>Autho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b="0" u="none" strike="noStrike" dirty="0">
                          <a:effectLst/>
                        </a:rPr>
                        <a:t>1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b="0" u="none" strike="noStrike" dirty="0">
                          <a:effectLst/>
                        </a:rPr>
                        <a:t>2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 dirty="0">
                          <a:effectLst/>
                        </a:rPr>
                        <a:t>3</a:t>
                      </a:r>
                      <a:endParaRPr lang="he-IL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b="0" u="none" strike="noStrike" dirty="0">
                          <a:effectLst/>
                        </a:rPr>
                        <a:t>4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5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6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7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8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9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000" u="none" strike="noStrike">
                          <a:effectLst/>
                        </a:rPr>
                        <a:t>10</a:t>
                      </a:r>
                      <a:endParaRPr lang="he-IL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ctr"/>
                </a:tc>
                <a:extLst>
                  <a:ext uri="{0D108BD9-81ED-4DB2-BD59-A6C34878D82A}">
                    <a16:rowId xmlns:a16="http://schemas.microsoft.com/office/drawing/2014/main" val="813182678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Du-Thanh et al. [4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3329567281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Gaebelein</a:t>
                      </a:r>
                      <a:r>
                        <a:rPr lang="en-US" sz="1000" u="none" strike="noStrike" dirty="0">
                          <a:effectLst/>
                        </a:rPr>
                        <a:t>-Wissing et al. [16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N/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3026037770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Imamura et al. [17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6663083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Monfrecola</a:t>
                      </a:r>
                      <a:r>
                        <a:rPr lang="en-US" sz="1000" u="none" strike="noStrike" dirty="0">
                          <a:effectLst/>
                        </a:rPr>
                        <a:t> et al. [18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2964576536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Uetsu</a:t>
                      </a:r>
                      <a:r>
                        <a:rPr lang="en-US" sz="1000" u="none" strike="noStrike" dirty="0">
                          <a:effectLst/>
                        </a:rPr>
                        <a:t> et al. [19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4553173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Fityan</a:t>
                      </a:r>
                      <a:r>
                        <a:rPr lang="en-US" sz="1000" u="none" strike="noStrike" dirty="0">
                          <a:effectLst/>
                        </a:rPr>
                        <a:t> et al. [20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445604522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Silpa-Archa et al. [21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5025944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Chong et al. [22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3003435109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Monfrecola</a:t>
                      </a:r>
                      <a:r>
                        <a:rPr lang="en-US" sz="1000" u="none" strike="noStrike" dirty="0">
                          <a:effectLst/>
                        </a:rPr>
                        <a:t> et al. [23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552180117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Grundmann et al. [24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1165156223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Beattie et al. [25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1110488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Reinauer et al. [26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356075754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Snast</a:t>
                      </a:r>
                      <a:r>
                        <a:rPr lang="en-US" sz="1000" u="none" strike="noStrike" dirty="0">
                          <a:effectLst/>
                        </a:rPr>
                        <a:t> et al. [27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9644444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Levi et al. [5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1760889657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Lyons et al. [28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4032441293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Beissert</a:t>
                      </a:r>
                      <a:r>
                        <a:rPr lang="en-US" sz="1000" u="none" strike="noStrike" dirty="0">
                          <a:effectLst/>
                        </a:rPr>
                        <a:t> et al. [6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2449373430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Chicharro</a:t>
                      </a:r>
                      <a:r>
                        <a:rPr lang="en-US" sz="1000" u="none" strike="noStrike" dirty="0">
                          <a:effectLst/>
                        </a:rPr>
                        <a:t> et al. [29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1884032404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Morgado-Carrasco et al. [30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469959401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Moncourier</a:t>
                      </a:r>
                      <a:r>
                        <a:rPr lang="en-US" sz="1000" u="none" strike="noStrike" dirty="0">
                          <a:effectLst/>
                        </a:rPr>
                        <a:t> et al. [31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2238556812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Sahuquillo</a:t>
                      </a:r>
                      <a:r>
                        <a:rPr lang="en-US" sz="1000" u="none" strike="noStrike" dirty="0">
                          <a:effectLst/>
                        </a:rPr>
                        <a:t>-Torralba et al. [32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3732952332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Rodríguez-Jiménez et al. [35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1659819703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Adamski et al. [33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4277817984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Hurabielle</a:t>
                      </a:r>
                      <a:r>
                        <a:rPr lang="en-US" sz="1000" u="none" strike="noStrike" dirty="0">
                          <a:effectLst/>
                        </a:rPr>
                        <a:t> et al. [34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/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1474898167"/>
                  </a:ext>
                </a:extLst>
              </a:tr>
              <a:tr h="17429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 dirty="0">
                          <a:effectLst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</a:rPr>
                        <a:t>Leenutaphong</a:t>
                      </a:r>
                      <a:r>
                        <a:rPr lang="en-US" sz="1000" u="none" strike="noStrike" dirty="0">
                          <a:effectLst/>
                        </a:rPr>
                        <a:t> et al</a:t>
                      </a:r>
                      <a:r>
                        <a:rPr lang="en-US" sz="1000" u="none" strike="noStrike">
                          <a:effectLst/>
                        </a:rPr>
                        <a:t>. [36]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010" marR="6010" marT="60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>
                          <a:effectLst/>
                        </a:rPr>
                        <a:t> </a:t>
                      </a:r>
                      <a:endParaRPr lang="he-IL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000" u="none" strike="noStrike" dirty="0">
                          <a:effectLst/>
                        </a:rPr>
                        <a:t> </a:t>
                      </a:r>
                      <a:endParaRPr lang="he-I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N/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0" marR="6010" marT="6010" marB="0" anchor="b"/>
                </a:tc>
                <a:extLst>
                  <a:ext uri="{0D108BD9-81ED-4DB2-BD59-A6C34878D82A}">
                    <a16:rowId xmlns:a16="http://schemas.microsoft.com/office/drawing/2014/main" val="2132652391"/>
                  </a:ext>
                </a:extLst>
              </a:tr>
            </a:tbl>
          </a:graphicData>
        </a:graphic>
      </p:graphicFrame>
      <p:graphicFrame>
        <p:nvGraphicFramePr>
          <p:cNvPr id="6" name="טבלה 5">
            <a:extLst>
              <a:ext uri="{FF2B5EF4-FFF2-40B4-BE49-F238E27FC236}">
                <a16:creationId xmlns:a16="http://schemas.microsoft.com/office/drawing/2014/main" id="{E6497E06-0269-AE00-E854-1223DE729E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7749474"/>
              </p:ext>
            </p:extLst>
          </p:nvPr>
        </p:nvGraphicFramePr>
        <p:xfrm>
          <a:off x="5592618" y="4010599"/>
          <a:ext cx="1320800" cy="5524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02577004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5438820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204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8475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ncl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458592"/>
                  </a:ext>
                </a:extLst>
              </a:tr>
            </a:tbl>
          </a:graphicData>
        </a:graphic>
      </p:graphicFrame>
      <p:graphicFrame>
        <p:nvGraphicFramePr>
          <p:cNvPr id="7" name="טבלה 6">
            <a:extLst>
              <a:ext uri="{FF2B5EF4-FFF2-40B4-BE49-F238E27FC236}">
                <a16:creationId xmlns:a16="http://schemas.microsoft.com/office/drawing/2014/main" id="{FBCBF87F-06BC-401F-8295-18C903C33D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2594401"/>
              </p:ext>
            </p:extLst>
          </p:nvPr>
        </p:nvGraphicFramePr>
        <p:xfrm>
          <a:off x="274320" y="4742180"/>
          <a:ext cx="7132348" cy="1841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688080396"/>
                    </a:ext>
                  </a:extLst>
                </a:gridCol>
                <a:gridCol w="6471948">
                  <a:extLst>
                    <a:ext uri="{9D8B030D-6E8A-4147-A177-3AD203B41FA5}">
                      <a16:colId xmlns:a16="http://schemas.microsoft.com/office/drawing/2014/main" val="2443484898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ere there clear criteria for inclusion in the case serie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2371851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Was the condition measured in a standard, reliable way for all participants included in the case series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9187296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Were valid methods used for identification of the condition for all participants included in the case series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035806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id the case series have consecutive inclusion of participant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146283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id the case series have complete inclusion of participant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651973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as there clear reporting of the demographics of the participants in the stud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494496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as there clear reporting of clinical information of the participant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1943165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ere the outcomes or follow-up results of cases clearly report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87859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as there clear reporting of the presenting sites'/clinics' demographic information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48741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Was statistical analysis appropriate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963952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53982571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621</Words>
  <Application>Microsoft Office PowerPoint</Application>
  <PresentationFormat>מסך רחב</PresentationFormat>
  <Paragraphs>301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ערכת נושא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ya Engler</dc:creator>
  <cp:lastModifiedBy>Maya Engler</cp:lastModifiedBy>
  <cp:revision>1</cp:revision>
  <dcterms:created xsi:type="dcterms:W3CDTF">2025-06-09T08:57:47Z</dcterms:created>
  <dcterms:modified xsi:type="dcterms:W3CDTF">2025-06-17T07:30:27Z</dcterms:modified>
</cp:coreProperties>
</file>